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E4ECA-80DD-4AFE-B974-FBC792936A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FE5F3F-3A07-4C91-899B-0656086E66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49148-8326-44FB-9ABC-A9FBBDA21E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DB627-F6F7-4811-A6A7-B0D3ED6900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7A838F-1BDB-4C97-B829-8E95FFFF8B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B45AE-EA10-4A85-A6AF-3694095126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DB884-55CE-4459-BE34-B2FE53F70E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C0D523-E15A-4215-8DC6-1B82D00EDA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11CA6-29E7-43A0-843A-17F2F481F7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98DD9-4A0B-457A-BEDE-7181D3FC93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CEEC6-C614-47F6-8A4E-813A0E02A1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33057-5551-48B8-B649-4AB955215C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295A72-7EE2-4266-847C-F4FA01603DC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71280" y="500040"/>
            <a:ext cx="9001440" cy="5749920"/>
            <a:chOff x="71280" y="500040"/>
            <a:chExt cx="9001440" cy="5749920"/>
          </a:xfrm>
        </p:grpSpPr>
        <p:pic>
          <p:nvPicPr>
            <p:cNvPr id="42" name="Picture 3" descr=""/>
            <p:cNvPicPr/>
            <p:nvPr/>
          </p:nvPicPr>
          <p:blipFill>
            <a:blip r:embed="rId1"/>
            <a:srcRect l="6484" t="7191" r="6484" b="2905"/>
            <a:stretch/>
          </p:blipFill>
          <p:spPr>
            <a:xfrm>
              <a:off x="71280" y="607680"/>
              <a:ext cx="9001440" cy="5642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2"/>
            <p:cNvSpPr/>
            <p:nvPr/>
          </p:nvSpPr>
          <p:spPr>
            <a:xfrm>
              <a:off x="2833560" y="500040"/>
              <a:ext cx="344988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. Distribution of IGF1R-alph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3"/>
          <p:cNvGrpSpPr/>
          <p:nvPr/>
        </p:nvGrpSpPr>
        <p:grpSpPr>
          <a:xfrm>
            <a:off x="71280" y="500040"/>
            <a:ext cx="9001440" cy="5783400"/>
            <a:chOff x="71280" y="500040"/>
            <a:chExt cx="9001440" cy="5783400"/>
          </a:xfrm>
        </p:grpSpPr>
        <p:pic>
          <p:nvPicPr>
            <p:cNvPr id="45" name="Picture 3" descr=""/>
            <p:cNvPicPr/>
            <p:nvPr/>
          </p:nvPicPr>
          <p:blipFill>
            <a:blip r:embed="rId1"/>
            <a:srcRect l="6497" t="7191" r="6484" b="1835"/>
            <a:stretch/>
          </p:blipFill>
          <p:spPr>
            <a:xfrm>
              <a:off x="71280" y="574560"/>
              <a:ext cx="9001440" cy="5708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2"/>
            <p:cNvSpPr/>
            <p:nvPr/>
          </p:nvSpPr>
          <p:spPr>
            <a:xfrm>
              <a:off x="2892600" y="500040"/>
              <a:ext cx="332172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. Distribution of IGF1R-bet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3"/>
          <p:cNvGrpSpPr/>
          <p:nvPr/>
        </p:nvGrpSpPr>
        <p:grpSpPr>
          <a:xfrm>
            <a:off x="71280" y="500040"/>
            <a:ext cx="9001440" cy="5783400"/>
            <a:chOff x="71280" y="500040"/>
            <a:chExt cx="9001440" cy="5783400"/>
          </a:xfrm>
        </p:grpSpPr>
        <p:pic>
          <p:nvPicPr>
            <p:cNvPr id="48" name="Picture 3" descr=""/>
            <p:cNvPicPr/>
            <p:nvPr/>
          </p:nvPicPr>
          <p:blipFill>
            <a:blip r:embed="rId1"/>
            <a:srcRect l="6484" t="7191" r="6484" b="1835"/>
            <a:stretch/>
          </p:blipFill>
          <p:spPr>
            <a:xfrm>
              <a:off x="71280" y="574560"/>
              <a:ext cx="9001440" cy="5708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2"/>
            <p:cNvSpPr/>
            <p:nvPr/>
          </p:nvSpPr>
          <p:spPr>
            <a:xfrm>
              <a:off x="3170520" y="500040"/>
              <a:ext cx="277596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. Distribution of IGF2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5"/>
          <p:cNvGrpSpPr/>
          <p:nvPr/>
        </p:nvGrpSpPr>
        <p:grpSpPr>
          <a:xfrm>
            <a:off x="23760" y="928800"/>
            <a:ext cx="9048960" cy="4881600"/>
            <a:chOff x="23760" y="928800"/>
            <a:chExt cx="9048960" cy="4881600"/>
          </a:xfrm>
        </p:grpSpPr>
        <p:grpSp>
          <p:nvGrpSpPr>
            <p:cNvPr id="51" name="Group 3"/>
            <p:cNvGrpSpPr/>
            <p:nvPr/>
          </p:nvGrpSpPr>
          <p:grpSpPr>
            <a:xfrm>
              <a:off x="70920" y="928800"/>
              <a:ext cx="9001800" cy="4881600"/>
              <a:chOff x="70920" y="928800"/>
              <a:chExt cx="9001800" cy="4881600"/>
            </a:xfrm>
          </p:grpSpPr>
          <p:pic>
            <p:nvPicPr>
              <p:cNvPr id="52" name="Picture 3" descr=""/>
              <p:cNvPicPr/>
              <p:nvPr/>
            </p:nvPicPr>
            <p:blipFill>
              <a:blip r:embed="rId1"/>
              <a:srcRect l="1441" t="9331" r="2063" b="2905"/>
              <a:stretch/>
            </p:blipFill>
            <p:spPr>
              <a:xfrm>
                <a:off x="70920" y="1047600"/>
                <a:ext cx="9001800" cy="4762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TextBox 2"/>
              <p:cNvSpPr/>
              <p:nvPr/>
            </p:nvSpPr>
            <p:spPr>
              <a:xfrm>
                <a:off x="3097080" y="928800"/>
                <a:ext cx="2928600" cy="368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D. Distribution of IGFBP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TextBox 4"/>
            <p:cNvSpPr/>
            <p:nvPr/>
          </p:nvSpPr>
          <p:spPr>
            <a:xfrm rot="16200000">
              <a:off x="-567360" y="3214440"/>
              <a:ext cx="1443960" cy="261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Percent of patient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42960" y="274680"/>
            <a:ext cx="8229600" cy="868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. Cut-off optimization for DFS and OS by correlation of logrank test p-value with IGF1R-alpha deciles as candidate cut-off poin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6" name="Group 6"/>
          <p:cNvGrpSpPr/>
          <p:nvPr/>
        </p:nvGrpSpPr>
        <p:grpSpPr>
          <a:xfrm>
            <a:off x="71280" y="1125360"/>
            <a:ext cx="9001440" cy="5538600"/>
            <a:chOff x="71280" y="1125360"/>
            <a:chExt cx="9001440" cy="5538600"/>
          </a:xfrm>
        </p:grpSpPr>
        <p:pic>
          <p:nvPicPr>
            <p:cNvPr id="57" name="Picture 4" descr=""/>
            <p:cNvPicPr/>
            <p:nvPr/>
          </p:nvPicPr>
          <p:blipFill>
            <a:blip r:embed="rId1"/>
            <a:srcRect l="640" t="11471" r="2588" b="1835"/>
            <a:stretch/>
          </p:blipFill>
          <p:spPr>
            <a:xfrm>
              <a:off x="71280" y="1125360"/>
              <a:ext cx="9001440" cy="4891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Straight Connector 5"/>
            <p:cNvSpPr/>
            <p:nvPr/>
          </p:nvSpPr>
          <p:spPr>
            <a:xfrm>
              <a:off x="4843440" y="1391760"/>
              <a:ext cx="0" cy="4069080"/>
            </a:xfrm>
            <a:prstGeom prst="line">
              <a:avLst/>
            </a:prstGeom>
            <a:ln w="255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7"/>
            <p:cNvSpPr/>
            <p:nvPr/>
          </p:nvSpPr>
          <p:spPr>
            <a:xfrm>
              <a:off x="356760" y="6143760"/>
              <a:ext cx="85014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ote: The vertical dotted line designates the selected cut-off point among those having the smallest p-values (indications of  significant correlation with DFS and OS to be explored further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. Cut-off optimization for DFS and OS by correlation of logrank test p-value with IGF1R-beta deciles as candidate cut-off poin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1" name="Group 5"/>
          <p:cNvGrpSpPr/>
          <p:nvPr/>
        </p:nvGrpSpPr>
        <p:grpSpPr>
          <a:xfrm>
            <a:off x="71280" y="1128600"/>
            <a:ext cx="9001440" cy="5535360"/>
            <a:chOff x="71280" y="1128600"/>
            <a:chExt cx="9001440" cy="5535360"/>
          </a:xfrm>
        </p:grpSpPr>
        <p:pic>
          <p:nvPicPr>
            <p:cNvPr id="62" name="Picture 4" descr=""/>
            <p:cNvPicPr/>
            <p:nvPr/>
          </p:nvPicPr>
          <p:blipFill>
            <a:blip r:embed="rId1"/>
            <a:srcRect l="640" t="11471" r="2588" b="1835"/>
            <a:stretch/>
          </p:blipFill>
          <p:spPr>
            <a:xfrm>
              <a:off x="71280" y="1128600"/>
              <a:ext cx="9001440" cy="489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Straight Connector 3"/>
            <p:cNvSpPr/>
            <p:nvPr/>
          </p:nvSpPr>
          <p:spPr>
            <a:xfrm>
              <a:off x="4843440" y="1392120"/>
              <a:ext cx="0" cy="4069080"/>
            </a:xfrm>
            <a:prstGeom prst="line">
              <a:avLst/>
            </a:prstGeom>
            <a:ln w="255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4"/>
            <p:cNvSpPr/>
            <p:nvPr/>
          </p:nvSpPr>
          <p:spPr>
            <a:xfrm>
              <a:off x="356760" y="6143760"/>
              <a:ext cx="85014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ote: The vertical dotted line designates the selected cut-off point among those having the smallest p-values (indications of  significant correlation with DFS and OS to be explored further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G. Cut-off optimization for DFS and OS by correlation of logrank test p-value with IGF2R deciles as candidate cut-off poin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6" name="Group 5"/>
          <p:cNvGrpSpPr/>
          <p:nvPr/>
        </p:nvGrpSpPr>
        <p:grpSpPr>
          <a:xfrm>
            <a:off x="71280" y="1128600"/>
            <a:ext cx="9001440" cy="5535360"/>
            <a:chOff x="71280" y="1128600"/>
            <a:chExt cx="9001440" cy="5535360"/>
          </a:xfrm>
        </p:grpSpPr>
        <p:pic>
          <p:nvPicPr>
            <p:cNvPr id="67" name="Picture 4" descr=""/>
            <p:cNvPicPr/>
            <p:nvPr/>
          </p:nvPicPr>
          <p:blipFill>
            <a:blip r:embed="rId1"/>
            <a:srcRect l="640" t="11471" r="2588" b="1835"/>
            <a:stretch/>
          </p:blipFill>
          <p:spPr>
            <a:xfrm>
              <a:off x="71280" y="1128600"/>
              <a:ext cx="9001440" cy="489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Straight Connector 3"/>
            <p:cNvSpPr/>
            <p:nvPr/>
          </p:nvSpPr>
          <p:spPr>
            <a:xfrm>
              <a:off x="4843440" y="1392120"/>
              <a:ext cx="0" cy="4069080"/>
            </a:xfrm>
            <a:prstGeom prst="line">
              <a:avLst/>
            </a:prstGeom>
            <a:ln w="255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4"/>
            <p:cNvSpPr/>
            <p:nvPr/>
          </p:nvSpPr>
          <p:spPr>
            <a:xfrm>
              <a:off x="356760" y="6143760"/>
              <a:ext cx="85014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ote: The vertical dotted line designates the selected cut-off point among those having the smallest p-values (indications of  significant correlation with DFS and OS to be explored further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H. Cut-off optimization for DFS and OS by correlation of logrank test p-value with IGFBP2 deciles as candidate cut-off poin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1" name="Group 6"/>
          <p:cNvGrpSpPr/>
          <p:nvPr/>
        </p:nvGrpSpPr>
        <p:grpSpPr>
          <a:xfrm>
            <a:off x="71280" y="1128600"/>
            <a:ext cx="9001440" cy="5656680"/>
            <a:chOff x="71280" y="1128600"/>
            <a:chExt cx="9001440" cy="5656680"/>
          </a:xfrm>
        </p:grpSpPr>
        <p:pic>
          <p:nvPicPr>
            <p:cNvPr id="72" name="Picture 4" descr=""/>
            <p:cNvPicPr/>
            <p:nvPr/>
          </p:nvPicPr>
          <p:blipFill>
            <a:blip r:embed="rId1"/>
            <a:srcRect l="640" t="11471" r="2588" b="1835"/>
            <a:stretch/>
          </p:blipFill>
          <p:spPr>
            <a:xfrm>
              <a:off x="71280" y="1128600"/>
              <a:ext cx="9001440" cy="4892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Straight Connector 3"/>
            <p:cNvSpPr/>
            <p:nvPr/>
          </p:nvSpPr>
          <p:spPr>
            <a:xfrm>
              <a:off x="1752480" y="1392120"/>
              <a:ext cx="0" cy="4068720"/>
            </a:xfrm>
            <a:prstGeom prst="line">
              <a:avLst/>
            </a:prstGeom>
            <a:ln w="255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Straight Connector 4"/>
            <p:cNvSpPr/>
            <p:nvPr/>
          </p:nvSpPr>
          <p:spPr>
            <a:xfrm>
              <a:off x="4851360" y="1368000"/>
              <a:ext cx="0" cy="4103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5"/>
            <p:cNvSpPr/>
            <p:nvPr/>
          </p:nvSpPr>
          <p:spPr>
            <a:xfrm>
              <a:off x="356760" y="6143760"/>
              <a:ext cx="850140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te: The vertical dotted line designates the cut off point with the smallest p-value and the solid line is the selected cut-off point at the median in order to increase the available sample size for analysis (i.e. below the cut off point) in the analysis by subtype.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08T09:27:26Z</dcterms:created>
  <dc:creator>George Kouvatseas</dc:creator>
  <dc:description/>
  <dc:language>en-US</dc:language>
  <cp:lastModifiedBy>GIANNIS MOUNTZIOS</cp:lastModifiedBy>
  <dcterms:modified xsi:type="dcterms:W3CDTF">2014-01-15T21:59:20Z</dcterms:modified>
  <cp:revision>31</cp:revision>
  <dc:subject/>
  <dc:title>Supplementary figure 1</dc:title>
</cp:coreProperties>
</file>